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EB565-9E08-43C5-827B-EA99544CCA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548C6-25C4-4A15-95F1-2F9A0D4CC7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44712-BFFC-4856-931A-60B725DB15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6C264-3E35-478B-B537-6A81848190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C05F5-B95C-4D43-B16C-5AA1D8A2E1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00C18-D25A-4D22-8DBD-C9E2D4CD3E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12B36-E6A6-40BC-8208-E7BB153E3A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DA8BB-5A2D-477B-A68C-9530218EF7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0C1D7-CD68-4431-83FE-38FFFEB38C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35EA6-5CBF-48BB-84D8-BD1ECF9A3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E90FE-9C4B-4D43-AE7C-FE6591FAA1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D5869-E6A7-4186-9190-DE61628AB6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DC6881-A98C-4BC1-8458-CEE50B3108C5}" type="slidenum">
              <a:rPr b="0" lang="en-NZ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1519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just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Genomic positions (cM) of the QTLs detected on the parental ‘Royal Gala’ (RG), ‘Starkrimson’ (STK) and ‘Granny Smith’ (GS). QTLs are represented by boxes, in which length represents the LOD-1 confidence interval and extended lines represent the LOD-2 confidence interval. Mapped candidate genes related to AUX/IAA are in bold underlined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rcRect l="0" t="0" r="49310" b="0"/>
          <a:stretch/>
        </p:blipFill>
        <p:spPr>
          <a:xfrm>
            <a:off x="2209680" y="1600200"/>
            <a:ext cx="411480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981000" y="1371600"/>
            <a:ext cx="8163000" cy="4551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Names and accession numbers of gene predictions in the apple genome with sequences of primers developed for candidate gene mapping in the population STKxG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1143000" y="2082960"/>
          <a:ext cx="7315200" cy="3860640"/>
        </p:xfrm>
        <a:graphic>
          <a:graphicData uri="http://schemas.openxmlformats.org/drawingml/2006/table">
            <a:tbl>
              <a:tblPr/>
              <a:tblGrid>
                <a:gridCol w="982800"/>
                <a:gridCol w="942840"/>
                <a:gridCol w="947880"/>
                <a:gridCol w="309240"/>
                <a:gridCol w="2149560"/>
                <a:gridCol w="851040"/>
                <a:gridCol w="565200"/>
                <a:gridCol w="566640"/>
              </a:tblGrid>
              <a:tr h="21096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pping in STKxG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3720">
                <a:tc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ene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ple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 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gregation typ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 rowSpan="8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x/I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IAA1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2955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TCAAACCCTCCATC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 x a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.6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GGATTGCAGTGGTCT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2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IAA127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4564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GAACTGAAGGAGCGA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 x 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1.7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GGAAGCCCAAGTCTA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1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IAA1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1767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TGATGCCCTAGCCAA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 x a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.4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2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AGAGGTGACTCCGCA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0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IAA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1468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TCTTTTTCTGCCCTG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 x a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3.6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0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AACTACAGTCCAAGGTATCAC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2760">
                <a:tc rowSpan="4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R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1796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CAAAGGAAGCACTCCA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 x a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GTGAATACGATGGGT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2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RF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1852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AGTTTTTAATTGTGACGGG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 x 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.2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CGCTTGTGTCTGTGT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096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R1/AF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FB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P00003058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GTCGTGAATGTGTGAA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 x 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.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ATTAGTCGGGCGTTTG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9T21:32:55Z</dcterms:created>
  <dc:creator>hrpbxg</dc:creator>
  <dc:description/>
  <dc:language>en-US</dc:language>
  <cp:lastModifiedBy>Karine Myriam David</cp:lastModifiedBy>
  <dcterms:modified xsi:type="dcterms:W3CDTF">2011-10-06T22:03:53Z</dcterms:modified>
  <cp:revision>14</cp:revision>
  <dc:subject/>
  <dc:title>Slide 1</dc:title>
</cp:coreProperties>
</file>